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revisionInfo.xml" ContentType="application/vnd.ms-powerpoint.revisioninfo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4"/>
  </p:sldMasterIdLst>
  <p:notesMasterIdLst>
    <p:notesMasterId r:id="rId6"/>
  </p:notesMasterIdLst>
  <p:sldIdLst>
    <p:sldId id="277" r:id="rId5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8781"/>
    <a:srgbClr val="FB787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0ED346C4-F49B-4161-832E-A0441B80BECA}" v="39" dt="2021-08-16T18:47:30.491"/>
    <p1510:client id="{2595CB98-CB29-5D72-E8F8-7CD66AA41C35}" v="6" dt="2021-08-16T19:22:08.445"/>
    <p1510:client id="{2E0C88B1-E08D-4AD6-B648-ACC61A094FE1}" v="19" dt="2019-11-04T15:10:24.790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6" autoAdjust="0"/>
    <p:restoredTop sz="82107" autoAdjust="0"/>
  </p:normalViewPr>
  <p:slideViewPr>
    <p:cSldViewPr snapToGrid="0">
      <p:cViewPr varScale="1">
        <p:scale>
          <a:sx n="96" d="100"/>
          <a:sy n="96" d="100"/>
        </p:scale>
        <p:origin x="2070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customXml" Target="../customXml/item3.xml"/><Relationship Id="rId7" Type="http://schemas.openxmlformats.org/officeDocument/2006/relationships/presProps" Target="pres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notesMaster" Target="notesMasters/notesMaster1.xml"/><Relationship Id="rId32" Type="http://schemas.microsoft.com/office/2015/10/relationships/revisionInfo" Target="revisionInfo.xml"/><Relationship Id="rId5" Type="http://schemas.openxmlformats.org/officeDocument/2006/relationships/slide" Target="slides/slide1.xml"/><Relationship Id="rId10" Type="http://schemas.openxmlformats.org/officeDocument/2006/relationships/tableStyles" Target="tableStyles.xml"/><Relationship Id="rId4" Type="http://schemas.openxmlformats.org/officeDocument/2006/relationships/slideMaster" Target="slideMasters/slideMaster1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E117100-8539-45FD-9961-28514C558970}" type="datetimeFigureOut">
              <a:rPr lang="en-US" smtClean="0"/>
              <a:t>10/5/2021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1D725D4-C992-4482-B73D-753C92FCF7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7107886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Figure </a:t>
            </a:r>
            <a:r>
              <a:rPr lang="en-US" dirty="0" err="1"/>
              <a:t>S2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01D725D4-C992-4482-B73D-753C92FCF73E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0630305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C63BD0-A076-484C-9DFB-36BFA6D4B856}" type="datetimeFigureOut">
              <a:rPr lang="en-US" smtClean="0"/>
              <a:t>10/5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6F00AA-EB44-45CA-AFF2-766B5B815C5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0043196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C63BD0-A076-484C-9DFB-36BFA6D4B856}" type="datetimeFigureOut">
              <a:rPr lang="en-US" smtClean="0"/>
              <a:t>10/5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6F00AA-EB44-45CA-AFF2-766B5B815C5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8100005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C63BD0-A076-484C-9DFB-36BFA6D4B856}" type="datetimeFigureOut">
              <a:rPr lang="en-US" smtClean="0"/>
              <a:t>10/5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6F00AA-EB44-45CA-AFF2-766B5B815C5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0141635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C63BD0-A076-484C-9DFB-36BFA6D4B856}" type="datetimeFigureOut">
              <a:rPr lang="en-US" smtClean="0"/>
              <a:t>10/5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6F00AA-EB44-45CA-AFF2-766B5B815C5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5130818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C63BD0-A076-484C-9DFB-36BFA6D4B856}" type="datetimeFigureOut">
              <a:rPr lang="en-US" smtClean="0"/>
              <a:t>10/5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6F00AA-EB44-45CA-AFF2-766B5B815C5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0984703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C63BD0-A076-484C-9DFB-36BFA6D4B856}" type="datetimeFigureOut">
              <a:rPr lang="en-US" smtClean="0"/>
              <a:t>10/5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6F00AA-EB44-45CA-AFF2-766B5B815C5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0959470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C63BD0-A076-484C-9DFB-36BFA6D4B856}" type="datetimeFigureOut">
              <a:rPr lang="en-US" smtClean="0"/>
              <a:t>10/5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6F00AA-EB44-45CA-AFF2-766B5B815C5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0076180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C63BD0-A076-484C-9DFB-36BFA6D4B856}" type="datetimeFigureOut">
              <a:rPr lang="en-US" smtClean="0"/>
              <a:t>10/5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6F00AA-EB44-45CA-AFF2-766B5B815C5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3540783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C63BD0-A076-484C-9DFB-36BFA6D4B856}" type="datetimeFigureOut">
              <a:rPr lang="en-US" smtClean="0"/>
              <a:t>10/5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6F00AA-EB44-45CA-AFF2-766B5B815C5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4291966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C63BD0-A076-484C-9DFB-36BFA6D4B856}" type="datetimeFigureOut">
              <a:rPr lang="en-US" smtClean="0"/>
              <a:t>10/5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6F00AA-EB44-45CA-AFF2-766B5B815C5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7456604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C63BD0-A076-484C-9DFB-36BFA6D4B856}" type="datetimeFigureOut">
              <a:rPr lang="en-US" smtClean="0"/>
              <a:t>10/5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6F00AA-EB44-45CA-AFF2-766B5B815C5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6907056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CC63BD0-A076-484C-9DFB-36BFA6D4B856}" type="datetimeFigureOut">
              <a:rPr lang="en-US" smtClean="0"/>
              <a:t>10/5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36F00AA-EB44-45CA-AFF2-766B5B815C5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975685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="" xmlns:a16="http://schemas.microsoft.com/office/drawing/2014/main" id="{D799074D-D643-4D44-8F0F-77673C0B97F0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479" b="5328"/>
          <a:stretch/>
        </p:blipFill>
        <p:spPr>
          <a:xfrm>
            <a:off x="404036" y="733503"/>
            <a:ext cx="8431471" cy="5103771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="" xmlns:a16="http://schemas.microsoft.com/office/drawing/2014/main" id="{2E0A185D-7B62-4663-BB86-B56EFB6C479B}"/>
              </a:ext>
            </a:extLst>
          </p:cNvPr>
          <p:cNvSpPr txBox="1"/>
          <p:nvPr/>
        </p:nvSpPr>
        <p:spPr>
          <a:xfrm rot="16200000">
            <a:off x="-1561535" y="3100721"/>
            <a:ext cx="356180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Log10(</a:t>
            </a:r>
            <a:r>
              <a:rPr lang="en-US" dirty="0" err="1"/>
              <a:t>tpm</a:t>
            </a:r>
            <a:r>
              <a:rPr lang="en-US" dirty="0"/>
              <a:t>) for all genes per sample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="" xmlns:a16="http://schemas.microsoft.com/office/drawing/2014/main" id="{D022DA3C-D05D-4FC1-B1F7-6667F46E7666}"/>
              </a:ext>
            </a:extLst>
          </p:cNvPr>
          <p:cNvSpPr txBox="1"/>
          <p:nvPr/>
        </p:nvSpPr>
        <p:spPr>
          <a:xfrm>
            <a:off x="1895850" y="5837274"/>
            <a:ext cx="535229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Normalized reads counts relative to a reference sample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="" xmlns:a16="http://schemas.microsoft.com/office/drawing/2014/main" id="{8E7407A0-3E24-4E72-881F-9311F7FC94F0}"/>
              </a:ext>
            </a:extLst>
          </p:cNvPr>
          <p:cNvSpPr txBox="1"/>
          <p:nvPr/>
        </p:nvSpPr>
        <p:spPr>
          <a:xfrm>
            <a:off x="0" y="6511267"/>
            <a:ext cx="10424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igure </a:t>
            </a:r>
            <a:r>
              <a:rPr lang="en-US" dirty="0" err="1"/>
              <a:t>S2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62942235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452B68F5B41D3D4CB7DDB63ACBDA9D3F" ma:contentTypeVersion="4" ma:contentTypeDescription="Create a new document." ma:contentTypeScope="" ma:versionID="ece86e7b5991fa21723c3e829ab5baf8">
  <xsd:schema xmlns:xsd="http://www.w3.org/2001/XMLSchema" xmlns:xs="http://www.w3.org/2001/XMLSchema" xmlns:p="http://schemas.microsoft.com/office/2006/metadata/properties" xmlns:ns2="3959f516-b9e9-4456-bdfc-fe1dd2ed4b6b" targetNamespace="http://schemas.microsoft.com/office/2006/metadata/properties" ma:root="true" ma:fieldsID="1634c693bbbd979c041f0b831c5dc32a" ns2:_="">
    <xsd:import namespace="3959f516-b9e9-4456-bdfc-fe1dd2ed4b6b"/>
    <xsd:element name="properties">
      <xsd:complexType>
        <xsd:sequence>
          <xsd:element name="documentManagement">
            <xsd:complexType>
              <xsd:all>
                <xsd:element ref="ns2:MediaServiceMetadata" minOccurs="0"/>
                <xsd:element ref="ns2:MediaServiceFastMetadata" minOccurs="0"/>
                <xsd:element ref="ns2:MediaServiceAutoKeyPoints" minOccurs="0"/>
                <xsd:element ref="ns2:MediaServiceKeyPoint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3959f516-b9e9-4456-bdfc-fe1dd2ed4b6b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KeyPoints" ma:index="10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1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/>
</p:properties>
</file>

<file path=customXml/itemProps1.xml><?xml version="1.0" encoding="utf-8"?>
<ds:datastoreItem xmlns:ds="http://schemas.openxmlformats.org/officeDocument/2006/customXml" ds:itemID="{A3135EF0-FB84-4E35-BCD0-BEA1F493A072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3959f516-b9e9-4456-bdfc-fe1dd2ed4b6b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2.xml><?xml version="1.0" encoding="utf-8"?>
<ds:datastoreItem xmlns:ds="http://schemas.openxmlformats.org/officeDocument/2006/customXml" ds:itemID="{31863473-5D9B-4D8C-B52F-643ECE5E5C79}">
  <ds:schemaRefs>
    <ds:schemaRef ds:uri="http://schemas.microsoft.com/sharepoint/v3/contenttype/forms"/>
  </ds:schemaRefs>
</ds:datastoreItem>
</file>

<file path=customXml/itemProps3.xml><?xml version="1.0" encoding="utf-8"?>
<ds:datastoreItem xmlns:ds="http://schemas.openxmlformats.org/officeDocument/2006/customXml" ds:itemID="{B281B24D-E0BB-4163-937A-7C0904938C66}">
  <ds:schemaRefs>
    <ds:schemaRef ds:uri="http://schemas.microsoft.com/office/2006/metadata/properties"/>
    <ds:schemaRef ds:uri="http://schemas.microsoft.com/office/infopath/2007/PartnerControls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5731</TotalTime>
  <Words>20</Words>
  <Application>Microsoft Office PowerPoint</Application>
  <PresentationFormat>On-screen Show (4:3)</PresentationFormat>
  <Paragraphs>5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Oziolor, Elias</dc:creator>
  <cp:lastModifiedBy>Sivagnanam K.</cp:lastModifiedBy>
  <cp:revision>208</cp:revision>
  <dcterms:created xsi:type="dcterms:W3CDTF">2019-05-21T14:29:01Z</dcterms:created>
  <dcterms:modified xsi:type="dcterms:W3CDTF">2021-10-05T11:52:32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452B68F5B41D3D4CB7DDB63ACBDA9D3F</vt:lpwstr>
  </property>
</Properties>
</file>